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65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254"/>
    <p:restoredTop sz="94607"/>
  </p:normalViewPr>
  <p:slideViewPr>
    <p:cSldViewPr snapToGrid="0">
      <p:cViewPr varScale="1">
        <p:scale>
          <a:sx n="119" d="100"/>
          <a:sy n="119" d="100"/>
        </p:scale>
        <p:origin x="40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C586A1-8972-9048-B818-041479E66141}" type="datetimeFigureOut">
              <a:rPr lang="en-US" smtClean="0"/>
              <a:t>3/11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80DA42-6C5B-B54A-A1EC-66E87E6F46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01419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D7C89E-8E89-C1A8-F5CE-E67844577E5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4F3695E-84FA-6722-04C5-E11F466F67E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14EA17-F084-E365-32FB-88994B8BB5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3B31E-B6E0-E248-A3A9-6E295D19908C}" type="datetimeFigureOut">
              <a:rPr lang="en-US" smtClean="0"/>
              <a:t>3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20B6F1-203D-66E1-5BB0-753B5791F5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1660A2-FB67-9E24-288D-E3273AE611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79A16-3A9B-9642-93E9-4E69082BEF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7760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CA9057-8C7E-A386-B9C1-FE0CED0283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8E2350-78B2-8527-E11E-30B28B5736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D0C60D-B308-0476-BD01-CB2DCF7D0A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3B31E-B6E0-E248-A3A9-6E295D19908C}" type="datetimeFigureOut">
              <a:rPr lang="en-US" smtClean="0"/>
              <a:t>3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595C00-3988-B80D-5F43-F24B8423C3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20F4D8-C9DF-FD57-8155-E376FB8B5C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79A16-3A9B-9642-93E9-4E69082BEF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916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D4EC9B0-FEFC-952A-9FE3-FD764B1A8C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E7C4F8-3ED5-0265-96E2-A8AAF4EC13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B5833E-F84A-FB7E-FFF5-B29C6191A8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3B31E-B6E0-E248-A3A9-6E295D19908C}" type="datetimeFigureOut">
              <a:rPr lang="en-US" smtClean="0"/>
              <a:t>3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0DA52A-1713-CBF9-4D00-5988F7086A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5B38AD-2C7F-967F-4A85-8FC7973590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79A16-3A9B-9642-93E9-4E69082BEF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2766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73C855-C51B-E30F-31B4-14003A39AF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B396DA-6E86-A292-AC96-31B99FFD79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A5B53A-DC92-FC04-4286-A7FD2F1D95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3B31E-B6E0-E248-A3A9-6E295D19908C}" type="datetimeFigureOut">
              <a:rPr lang="en-US" smtClean="0"/>
              <a:t>3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34069E-DF5A-1764-6876-7AD6C68413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81B40B-405F-A695-F9DC-100BC5308D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79A16-3A9B-9642-93E9-4E69082BEF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0195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1B0A07-84FB-61FC-1A4F-7114803A18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F4111A-D57B-ADD1-C9C9-C1E703F88D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AAE964-C841-74BE-EB97-380D0E0CA9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3B31E-B6E0-E248-A3A9-6E295D19908C}" type="datetimeFigureOut">
              <a:rPr lang="en-US" smtClean="0"/>
              <a:t>3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5FCF88-60BC-FF45-6429-A8FDFE0426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FEFC9F-B432-B1D6-2498-616B3E4FF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79A16-3A9B-9642-93E9-4E69082BEF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0139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D163E7-0A46-495C-9224-6D71ECD007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E6C1DE-C5C4-CAA6-E2A2-2BBC589AAD8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B564B53-12D9-1A7A-9F53-7A92EE0AA0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73D0D6-3FFD-8436-55A2-DBE8B86CD2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3B31E-B6E0-E248-A3A9-6E295D19908C}" type="datetimeFigureOut">
              <a:rPr lang="en-US" smtClean="0"/>
              <a:t>3/1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85A6A6-6A4E-F044-3D63-459A1D780B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AB7725-69FE-41A4-7461-D00C810DF3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79A16-3A9B-9642-93E9-4E69082BEF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2410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140FA0-498C-3A0E-D86E-02067CAF66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206E83-9CCF-6019-5432-23EDB5B3F1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56F8C99-DAAA-0CFC-B0DC-25556BDBF8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6C80CC6-32E1-BB45-50CD-70C4948D064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29E0FD5-2957-6832-5DE2-F44C757F5AE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170E2A4-F020-E478-829C-E098D590B1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3B31E-B6E0-E248-A3A9-6E295D19908C}" type="datetimeFigureOut">
              <a:rPr lang="en-US" smtClean="0"/>
              <a:t>3/11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7ED368-1080-0DBF-07A6-DAFDA39886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6242C78-369D-8711-7F4E-3016A1217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79A16-3A9B-9642-93E9-4E69082BEF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7477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C97303-7D9E-3353-7AF0-C4F7D754FC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98698E8-74C4-C8B3-A3F2-EDA838C6F2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3B31E-B6E0-E248-A3A9-6E295D19908C}" type="datetimeFigureOut">
              <a:rPr lang="en-US" smtClean="0"/>
              <a:t>3/11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45E8487-C20F-7119-B9F9-3C64397481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E9E34D2-AAE9-9A4B-4B05-07E1D96B5D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79A16-3A9B-9642-93E9-4E69082BEF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8929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008C683-380E-FF5A-2E95-D80717FDF0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3B31E-B6E0-E248-A3A9-6E295D19908C}" type="datetimeFigureOut">
              <a:rPr lang="en-US" smtClean="0"/>
              <a:t>3/11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B48CAA2-9ABE-B3D4-A300-E590D7535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C878C86-3FBB-E30D-9952-2EBDAAF8CB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79A16-3A9B-9642-93E9-4E69082BEF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81567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1C2536-4E99-D3EA-54EB-2D1E02D1D0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764F38-2ADB-F1CA-C193-E103EBE120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0CAA374-D04A-3034-8DC9-1DBD68F61A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0C0C04-AF51-32DB-2B83-9F2ED41195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3B31E-B6E0-E248-A3A9-6E295D19908C}" type="datetimeFigureOut">
              <a:rPr lang="en-US" smtClean="0"/>
              <a:t>3/1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34C03C-C773-75BA-9D6B-ACEFE966C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537FFB-D8C2-8E9D-0F30-E2292D084F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79A16-3A9B-9642-93E9-4E69082BEF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991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962565-E0CF-F1F9-326D-C32424B1F6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1C85028-4465-5F47-5C29-0B801422353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872A60-44F3-0D34-342E-313D871E35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D473EB-4006-C5A7-B397-A406FBA186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3B31E-B6E0-E248-A3A9-6E295D19908C}" type="datetimeFigureOut">
              <a:rPr lang="en-US" smtClean="0"/>
              <a:t>3/1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AA71D8-1E22-4730-AB78-9FA4D70B1E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34D4D4-0B71-0D40-5A22-34C67652C7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79A16-3A9B-9642-93E9-4E69082BEF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0141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5C045F0-6950-D49F-88A4-B66A0E37A2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FF8D95-1C0B-1F04-37A5-4B6399D729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DE9AF4-5074-2669-2C43-9464E09842D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993B31E-B6E0-E248-A3A9-6E295D19908C}" type="datetimeFigureOut">
              <a:rPr lang="en-US" smtClean="0"/>
              <a:t>3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283504-380C-1DDD-353F-875A95A15B6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90C34E-EBA1-94CE-DE73-7DA5B97369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9279A16-3A9B-9642-93E9-4E69082BEF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0299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F212E9F1-CD87-EA41-B54A-D9EEECB8C3C6}"/>
              </a:ext>
            </a:extLst>
          </p:cNvPr>
          <p:cNvGrpSpPr/>
          <p:nvPr/>
        </p:nvGrpSpPr>
        <p:grpSpPr>
          <a:xfrm>
            <a:off x="1264306" y="1465066"/>
            <a:ext cx="3049708" cy="1790330"/>
            <a:chOff x="803673" y="1543693"/>
            <a:chExt cx="3049708" cy="1790330"/>
          </a:xfrm>
        </p:grpSpPr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9EDD1C81-9D2E-5235-36E6-16AD9EC91551}"/>
                </a:ext>
              </a:extLst>
            </p:cNvPr>
            <p:cNvCxnSpPr/>
            <p:nvPr/>
          </p:nvCxnSpPr>
          <p:spPr>
            <a:xfrm>
              <a:off x="1519544" y="2958976"/>
              <a:ext cx="959213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3D053242-7DB0-BDBC-B648-7582DF6FED8A}"/>
                </a:ext>
              </a:extLst>
            </p:cNvPr>
            <p:cNvCxnSpPr>
              <a:cxnSpLocks/>
            </p:cNvCxnSpPr>
            <p:nvPr/>
          </p:nvCxnSpPr>
          <p:spPr>
            <a:xfrm>
              <a:off x="2571117" y="2963145"/>
              <a:ext cx="111125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825512BB-015F-C44D-A716-CF04E5D778B5}"/>
                </a:ext>
              </a:extLst>
            </p:cNvPr>
            <p:cNvGrpSpPr/>
            <p:nvPr/>
          </p:nvGrpSpPr>
          <p:grpSpPr>
            <a:xfrm>
              <a:off x="803673" y="1543693"/>
              <a:ext cx="3049708" cy="1790330"/>
              <a:chOff x="803673" y="1543693"/>
              <a:chExt cx="3049708" cy="1790330"/>
            </a:xfrm>
          </p:grpSpPr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F77FDE8E-582E-0108-8B54-132BD28F832B}"/>
                  </a:ext>
                </a:extLst>
              </p:cNvPr>
              <p:cNvSpPr txBox="1"/>
              <p:nvPr/>
            </p:nvSpPr>
            <p:spPr>
              <a:xfrm flipH="1">
                <a:off x="803673" y="1913272"/>
                <a:ext cx="6669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p-p65</a:t>
                </a:r>
              </a:p>
            </p:txBody>
          </p:sp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D7A3872C-F50C-D245-93C0-64BA64C2F8B3}"/>
                  </a:ext>
                </a:extLst>
              </p:cNvPr>
              <p:cNvGrpSpPr/>
              <p:nvPr/>
            </p:nvGrpSpPr>
            <p:grpSpPr>
              <a:xfrm>
                <a:off x="1104133" y="1543693"/>
                <a:ext cx="2749248" cy="1790330"/>
                <a:chOff x="1104133" y="1543693"/>
                <a:chExt cx="2749248" cy="1790330"/>
              </a:xfrm>
            </p:grpSpPr>
            <p:grpSp>
              <p:nvGrpSpPr>
                <p:cNvPr id="39" name="Group 38">
                  <a:extLst>
                    <a:ext uri="{FF2B5EF4-FFF2-40B4-BE49-F238E27FC236}">
                      <a16:creationId xmlns:a16="http://schemas.microsoft.com/office/drawing/2014/main" id="{29D6F3E4-A25D-9F48-C142-D1AF1447CF69}"/>
                    </a:ext>
                  </a:extLst>
                </p:cNvPr>
                <p:cNvGrpSpPr/>
                <p:nvPr/>
              </p:nvGrpSpPr>
              <p:grpSpPr>
                <a:xfrm flipH="1">
                  <a:off x="1104133" y="1543693"/>
                  <a:ext cx="2749248" cy="1337419"/>
                  <a:chOff x="3956470" y="1141218"/>
                  <a:chExt cx="2749248" cy="1337419"/>
                </a:xfrm>
              </p:grpSpPr>
              <p:sp>
                <p:nvSpPr>
                  <p:cNvPr id="40" name="TextBox 39">
                    <a:extLst>
                      <a:ext uri="{FF2B5EF4-FFF2-40B4-BE49-F238E27FC236}">
                        <a16:creationId xmlns:a16="http://schemas.microsoft.com/office/drawing/2014/main" id="{A8B9ED27-3014-911E-3B67-5F2624265303}"/>
                      </a:ext>
                    </a:extLst>
                  </p:cNvPr>
                  <p:cNvSpPr txBox="1"/>
                  <p:nvPr/>
                </p:nvSpPr>
                <p:spPr>
                  <a:xfrm>
                    <a:off x="3956470" y="1141218"/>
                    <a:ext cx="2749248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4hr Spleen</a:t>
                    </a:r>
                  </a:p>
                </p:txBody>
              </p:sp>
              <p:pic>
                <p:nvPicPr>
                  <p:cNvPr id="43" name="Picture 42">
                    <a:extLst>
                      <a:ext uri="{FF2B5EF4-FFF2-40B4-BE49-F238E27FC236}">
                        <a16:creationId xmlns:a16="http://schemas.microsoft.com/office/drawing/2014/main" id="{CA4FEC89-4C44-8F95-A8EB-ED720B0E83F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/>
                  <a:stretch>
                    <a:fillRect/>
                  </a:stretch>
                </p:blipFill>
                <p:spPr>
                  <a:xfrm>
                    <a:off x="4198235" y="1883805"/>
                    <a:ext cx="2151749" cy="283464"/>
                  </a:xfrm>
                  <a:prstGeom prst="rect">
                    <a:avLst/>
                  </a:prstGeom>
                  <a:scene3d>
                    <a:camera prst="orthographicFront">
                      <a:rot lat="0" lon="300000" rev="0"/>
                    </a:camera>
                    <a:lightRig rig="threePt" dir="t"/>
                  </a:scene3d>
                </p:spPr>
              </p:pic>
              <p:pic>
                <p:nvPicPr>
                  <p:cNvPr id="45" name="Picture 44">
                    <a:extLst>
                      <a:ext uri="{FF2B5EF4-FFF2-40B4-BE49-F238E27FC236}">
                        <a16:creationId xmlns:a16="http://schemas.microsoft.com/office/drawing/2014/main" id="{F14FE206-EF28-B47F-6F84-6398207AA37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4140184" y="1576600"/>
                    <a:ext cx="2197100" cy="190500"/>
                  </a:xfrm>
                  <a:prstGeom prst="rect">
                    <a:avLst/>
                  </a:prstGeom>
                </p:spPr>
              </p:pic>
              <p:pic>
                <p:nvPicPr>
                  <p:cNvPr id="38" name="Picture 37">
                    <a:extLst>
                      <a:ext uri="{FF2B5EF4-FFF2-40B4-BE49-F238E27FC236}">
                        <a16:creationId xmlns:a16="http://schemas.microsoft.com/office/drawing/2014/main" id="{C8FA2760-2A3B-9D9B-3D38-02E7B86E607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 flipH="1">
                    <a:off x="4127484" y="2224637"/>
                    <a:ext cx="2222500" cy="254000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ED18CB6A-C6B8-8F43-A62E-5FCD2BF41843}"/>
                    </a:ext>
                  </a:extLst>
                </p:cNvPr>
                <p:cNvSpPr txBox="1"/>
                <p:nvPr/>
              </p:nvSpPr>
              <p:spPr>
                <a:xfrm>
                  <a:off x="1738319" y="3026246"/>
                  <a:ext cx="170177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                </a:t>
                  </a:r>
                  <a:r>
                    <a:rPr lang="en-US" sz="14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sc</a:t>
                  </a:r>
                  <a:r>
                    <a:rPr lang="en-US" sz="140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/- </a:t>
                  </a:r>
                  <a:endParaRPr 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53875DC4-24BC-CB48-B3FA-22998F4E02E1}"/>
                  </a:ext>
                </a:extLst>
              </p:cNvPr>
              <p:cNvSpPr txBox="1"/>
              <p:nvPr/>
            </p:nvSpPr>
            <p:spPr>
              <a:xfrm flipH="1">
                <a:off x="956068" y="2270068"/>
                <a:ext cx="6669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p65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B4002EB3-2D3D-F54C-9BDA-9260A860A02A}"/>
                  </a:ext>
                </a:extLst>
              </p:cNvPr>
              <p:cNvSpPr txBox="1"/>
              <p:nvPr/>
            </p:nvSpPr>
            <p:spPr>
              <a:xfrm flipH="1">
                <a:off x="871795" y="2594591"/>
                <a:ext cx="6669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</a:p>
            </p:txBody>
          </p:sp>
        </p:grp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07F33897-BB76-2D44-9643-D8037FC80D0E}"/>
              </a:ext>
            </a:extLst>
          </p:cNvPr>
          <p:cNvGrpSpPr/>
          <p:nvPr/>
        </p:nvGrpSpPr>
        <p:grpSpPr>
          <a:xfrm>
            <a:off x="4605170" y="1409671"/>
            <a:ext cx="2685318" cy="1909176"/>
            <a:chOff x="6393143" y="1448490"/>
            <a:chExt cx="2685318" cy="1909176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2D3B1E23-26AF-784A-A095-7ACF29F99854}"/>
                </a:ext>
              </a:extLst>
            </p:cNvPr>
            <p:cNvGrpSpPr/>
            <p:nvPr/>
          </p:nvGrpSpPr>
          <p:grpSpPr>
            <a:xfrm>
              <a:off x="6717226" y="1448490"/>
              <a:ext cx="2361235" cy="1909176"/>
              <a:chOff x="6717226" y="1448490"/>
              <a:chExt cx="2361235" cy="1909176"/>
            </a:xfrm>
          </p:grpSpPr>
          <p:grpSp>
            <p:nvGrpSpPr>
              <p:cNvPr id="96" name="Group 95">
                <a:extLst>
                  <a:ext uri="{FF2B5EF4-FFF2-40B4-BE49-F238E27FC236}">
                    <a16:creationId xmlns:a16="http://schemas.microsoft.com/office/drawing/2014/main" id="{11EB23AA-E2AC-7404-2A73-B6B22A12CA9B}"/>
                  </a:ext>
                </a:extLst>
              </p:cNvPr>
              <p:cNvGrpSpPr/>
              <p:nvPr/>
            </p:nvGrpSpPr>
            <p:grpSpPr>
              <a:xfrm>
                <a:off x="6717226" y="1448490"/>
                <a:ext cx="2361235" cy="1550770"/>
                <a:chOff x="5915250" y="1188006"/>
                <a:chExt cx="2361235" cy="1550770"/>
              </a:xfrm>
            </p:grpSpPr>
            <p:grpSp>
              <p:nvGrpSpPr>
                <p:cNvPr id="37" name="Group 36">
                  <a:extLst>
                    <a:ext uri="{FF2B5EF4-FFF2-40B4-BE49-F238E27FC236}">
                      <a16:creationId xmlns:a16="http://schemas.microsoft.com/office/drawing/2014/main" id="{2BBC6B6C-FDF8-D3A6-14E7-8CB3B903FB52}"/>
                    </a:ext>
                  </a:extLst>
                </p:cNvPr>
                <p:cNvGrpSpPr/>
                <p:nvPr/>
              </p:nvGrpSpPr>
              <p:grpSpPr>
                <a:xfrm>
                  <a:off x="5915250" y="1188006"/>
                  <a:ext cx="2361235" cy="1457704"/>
                  <a:chOff x="1537212" y="2030972"/>
                  <a:chExt cx="2361235" cy="1457704"/>
                </a:xfrm>
              </p:grpSpPr>
              <p:grpSp>
                <p:nvGrpSpPr>
                  <p:cNvPr id="21" name="Group 20">
                    <a:extLst>
                      <a:ext uri="{FF2B5EF4-FFF2-40B4-BE49-F238E27FC236}">
                        <a16:creationId xmlns:a16="http://schemas.microsoft.com/office/drawing/2014/main" id="{2C424EE7-861F-486F-82AB-2FA8E61A4C66}"/>
                      </a:ext>
                    </a:extLst>
                  </p:cNvPr>
                  <p:cNvGrpSpPr/>
                  <p:nvPr/>
                </p:nvGrpSpPr>
                <p:grpSpPr>
                  <a:xfrm>
                    <a:off x="1901430" y="2436250"/>
                    <a:ext cx="1739900" cy="1052426"/>
                    <a:chOff x="7005865" y="3273739"/>
                    <a:chExt cx="1739900" cy="1052426"/>
                  </a:xfrm>
                </p:grpSpPr>
                <p:pic>
                  <p:nvPicPr>
                    <p:cNvPr id="22" name="Picture 21">
                      <a:extLst>
                        <a:ext uri="{FF2B5EF4-FFF2-40B4-BE49-F238E27FC236}">
                          <a16:creationId xmlns:a16="http://schemas.microsoft.com/office/drawing/2014/main" id="{F475C60B-9BC0-328B-95A0-D6BB95B8777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5"/>
                    <a:stretch>
                      <a:fillRect/>
                    </a:stretch>
                  </p:blipFill>
                  <p:spPr>
                    <a:xfrm flipH="1">
                      <a:off x="7005865" y="3273739"/>
                      <a:ext cx="1739900" cy="304838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3" name="Picture 22">
                      <a:extLst>
                        <a:ext uri="{FF2B5EF4-FFF2-40B4-BE49-F238E27FC236}">
                          <a16:creationId xmlns:a16="http://schemas.microsoft.com/office/drawing/2014/main" id="{D2236574-0590-5EB3-6837-923453E7B086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6"/>
                    <a:stretch>
                      <a:fillRect/>
                    </a:stretch>
                  </p:blipFill>
                  <p:spPr>
                    <a:xfrm flipH="1">
                      <a:off x="7005865" y="3685671"/>
                      <a:ext cx="1739900" cy="2667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4" name="Picture 23">
                      <a:extLst>
                        <a:ext uri="{FF2B5EF4-FFF2-40B4-BE49-F238E27FC236}">
                          <a16:creationId xmlns:a16="http://schemas.microsoft.com/office/drawing/2014/main" id="{6682FF2F-09E8-36C6-F6D6-F6B07C271DB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 flipH="1">
                      <a:off x="7005865" y="4059465"/>
                      <a:ext cx="1739900" cy="266700"/>
                    </a:xfrm>
                    <a:prstGeom prst="rect">
                      <a:avLst/>
                    </a:prstGeom>
                  </p:spPr>
                </p:pic>
              </p:grpSp>
              <p:sp>
                <p:nvSpPr>
                  <p:cNvPr id="36" name="TextBox 35">
                    <a:extLst>
                      <a:ext uri="{FF2B5EF4-FFF2-40B4-BE49-F238E27FC236}">
                        <a16:creationId xmlns:a16="http://schemas.microsoft.com/office/drawing/2014/main" id="{A27306DF-CE7A-E3DB-9AB8-D1D6C3DF0823}"/>
                      </a:ext>
                    </a:extLst>
                  </p:cNvPr>
                  <p:cNvSpPr txBox="1"/>
                  <p:nvPr/>
                </p:nvSpPr>
                <p:spPr>
                  <a:xfrm>
                    <a:off x="1537212" y="2030972"/>
                    <a:ext cx="2361235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8hr Spleen </a:t>
                    </a:r>
                  </a:p>
                </p:txBody>
              </p:sp>
            </p:grpSp>
            <p:cxnSp>
              <p:nvCxnSpPr>
                <p:cNvPr id="90" name="Straight Connector 89">
                  <a:extLst>
                    <a:ext uri="{FF2B5EF4-FFF2-40B4-BE49-F238E27FC236}">
                      <a16:creationId xmlns:a16="http://schemas.microsoft.com/office/drawing/2014/main" id="{FEC88EA7-F57D-A7EC-9A81-D60B9BEC2F2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279468" y="2738776"/>
                  <a:ext cx="731520" cy="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93" name="Straight Connector 92">
                  <a:extLst>
                    <a:ext uri="{FF2B5EF4-FFF2-40B4-BE49-F238E27FC236}">
                      <a16:creationId xmlns:a16="http://schemas.microsoft.com/office/drawing/2014/main" id="{947AAF25-CA13-724F-AE84-95DD0EAA839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267070" y="2738776"/>
                  <a:ext cx="752298" cy="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CB2B8A3B-295D-404B-ABC1-97CD953E6C53}"/>
                  </a:ext>
                </a:extLst>
              </p:cNvPr>
              <p:cNvSpPr txBox="1"/>
              <p:nvPr/>
            </p:nvSpPr>
            <p:spPr>
              <a:xfrm>
                <a:off x="7227982" y="3049889"/>
                <a:ext cx="164928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             </a:t>
                </a:r>
                <a:r>
                  <a:rPr lang="en-US" sz="14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Asc</a:t>
                </a:r>
                <a:r>
                  <a:rPr lang="en-US" sz="140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/- 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EAE62A7D-6BB2-E24B-842A-D655DB7D4558}"/>
                </a:ext>
              </a:extLst>
            </p:cNvPr>
            <p:cNvSpPr txBox="1"/>
            <p:nvPr/>
          </p:nvSpPr>
          <p:spPr>
            <a:xfrm flipH="1">
              <a:off x="6393143" y="1857344"/>
              <a:ext cx="6669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p-p65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7364BCDB-927C-0C4B-B017-BFAAA0BE4427}"/>
                </a:ext>
              </a:extLst>
            </p:cNvPr>
            <p:cNvSpPr txBox="1"/>
            <p:nvPr/>
          </p:nvSpPr>
          <p:spPr>
            <a:xfrm flipH="1">
              <a:off x="6545538" y="2257172"/>
              <a:ext cx="6669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p65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4B7C5596-CA60-AA42-94EB-FC6F78EBDE39}"/>
                </a:ext>
              </a:extLst>
            </p:cNvPr>
            <p:cNvSpPr txBox="1"/>
            <p:nvPr/>
          </p:nvSpPr>
          <p:spPr>
            <a:xfrm flipH="1">
              <a:off x="6461265" y="2581695"/>
              <a:ext cx="6669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8D7C15EC-183B-6C49-B2D0-241D3C6C0C67}"/>
              </a:ext>
            </a:extLst>
          </p:cNvPr>
          <p:cNvGrpSpPr/>
          <p:nvPr/>
        </p:nvGrpSpPr>
        <p:grpSpPr>
          <a:xfrm>
            <a:off x="7672936" y="1477860"/>
            <a:ext cx="2661142" cy="1781495"/>
            <a:chOff x="955299" y="4208264"/>
            <a:chExt cx="2661142" cy="1781495"/>
          </a:xfrm>
        </p:grpSpPr>
        <p:grpSp>
          <p:nvGrpSpPr>
            <p:cNvPr id="101" name="Group 100">
              <a:extLst>
                <a:ext uri="{FF2B5EF4-FFF2-40B4-BE49-F238E27FC236}">
                  <a16:creationId xmlns:a16="http://schemas.microsoft.com/office/drawing/2014/main" id="{ED7E0CE8-0933-A608-B977-FC49C26CB2B1}"/>
                </a:ext>
              </a:extLst>
            </p:cNvPr>
            <p:cNvGrpSpPr/>
            <p:nvPr/>
          </p:nvGrpSpPr>
          <p:grpSpPr>
            <a:xfrm>
              <a:off x="1255206" y="4208264"/>
              <a:ext cx="2361235" cy="1429850"/>
              <a:chOff x="1255206" y="4208264"/>
              <a:chExt cx="2361235" cy="1429850"/>
            </a:xfrm>
          </p:grpSpPr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9B8E1955-9356-7E8E-4652-981954E67311}"/>
                  </a:ext>
                </a:extLst>
              </p:cNvPr>
              <p:cNvGrpSpPr/>
              <p:nvPr/>
            </p:nvGrpSpPr>
            <p:grpSpPr>
              <a:xfrm>
                <a:off x="1255206" y="4208264"/>
                <a:ext cx="2361235" cy="1344620"/>
                <a:chOff x="1192600" y="2956145"/>
                <a:chExt cx="2361235" cy="1344620"/>
              </a:xfrm>
            </p:grpSpPr>
            <p:grpSp>
              <p:nvGrpSpPr>
                <p:cNvPr id="4" name="Group 3">
                  <a:extLst>
                    <a:ext uri="{FF2B5EF4-FFF2-40B4-BE49-F238E27FC236}">
                      <a16:creationId xmlns:a16="http://schemas.microsoft.com/office/drawing/2014/main" id="{CA4189D9-5E51-9F84-8CA8-92CA298FF426}"/>
                    </a:ext>
                  </a:extLst>
                </p:cNvPr>
                <p:cNvGrpSpPr/>
                <p:nvPr/>
              </p:nvGrpSpPr>
              <p:grpSpPr>
                <a:xfrm>
                  <a:off x="1565251" y="3383129"/>
                  <a:ext cx="1707720" cy="917636"/>
                  <a:chOff x="1565251" y="3383129"/>
                  <a:chExt cx="1707720" cy="917636"/>
                </a:xfrm>
              </p:grpSpPr>
              <p:pic>
                <p:nvPicPr>
                  <p:cNvPr id="5" name="Picture 4">
                    <a:extLst>
                      <a:ext uri="{FF2B5EF4-FFF2-40B4-BE49-F238E27FC236}">
                        <a16:creationId xmlns:a16="http://schemas.microsoft.com/office/drawing/2014/main" id="{299F3C62-0E7A-181A-CCAE-84C2FE5E3C3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8"/>
                  <a:stretch>
                    <a:fillRect/>
                  </a:stretch>
                </p:blipFill>
                <p:spPr>
                  <a:xfrm flipH="1">
                    <a:off x="1571171" y="4059465"/>
                    <a:ext cx="1701800" cy="241300"/>
                  </a:xfrm>
                  <a:prstGeom prst="rect">
                    <a:avLst/>
                  </a:prstGeom>
                </p:spPr>
              </p:pic>
              <p:pic>
                <p:nvPicPr>
                  <p:cNvPr id="6" name="Picture 5">
                    <a:extLst>
                      <a:ext uri="{FF2B5EF4-FFF2-40B4-BE49-F238E27FC236}">
                        <a16:creationId xmlns:a16="http://schemas.microsoft.com/office/drawing/2014/main" id="{1847CF2F-709D-BF05-B675-EE311A228EE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9"/>
                  <a:stretch>
                    <a:fillRect/>
                  </a:stretch>
                </p:blipFill>
                <p:spPr>
                  <a:xfrm flipH="1">
                    <a:off x="1565251" y="3759763"/>
                    <a:ext cx="1701800" cy="241300"/>
                  </a:xfrm>
                  <a:prstGeom prst="rect">
                    <a:avLst/>
                  </a:prstGeom>
                </p:spPr>
              </p:pic>
              <p:pic>
                <p:nvPicPr>
                  <p:cNvPr id="7" name="Picture 6">
                    <a:extLst>
                      <a:ext uri="{FF2B5EF4-FFF2-40B4-BE49-F238E27FC236}">
                        <a16:creationId xmlns:a16="http://schemas.microsoft.com/office/drawing/2014/main" id="{520AEE45-D29D-3F6C-8504-0C15CBB8F42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0"/>
                  <a:stretch>
                    <a:fillRect/>
                  </a:stretch>
                </p:blipFill>
                <p:spPr>
                  <a:xfrm flipH="1">
                    <a:off x="1565251" y="3383129"/>
                    <a:ext cx="1701800" cy="292100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53645E76-B829-9DAB-CDA8-587B33D05C3D}"/>
                    </a:ext>
                  </a:extLst>
                </p:cNvPr>
                <p:cNvSpPr txBox="1"/>
                <p:nvPr/>
              </p:nvSpPr>
              <p:spPr>
                <a:xfrm>
                  <a:off x="1192600" y="2956145"/>
                  <a:ext cx="2361235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8hr Liver </a:t>
                  </a:r>
                </a:p>
              </p:txBody>
            </p:sp>
          </p:grpSp>
          <p:cxnSp>
            <p:nvCxnSpPr>
              <p:cNvPr id="97" name="Straight Connector 96">
                <a:extLst>
                  <a:ext uri="{FF2B5EF4-FFF2-40B4-BE49-F238E27FC236}">
                    <a16:creationId xmlns:a16="http://schemas.microsoft.com/office/drawing/2014/main" id="{96BC71A1-594A-CFB2-A7CB-0CED82749A4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79615" y="5638114"/>
                <a:ext cx="73152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8" name="Straight Connector 97">
                <a:extLst>
                  <a:ext uri="{FF2B5EF4-FFF2-40B4-BE49-F238E27FC236}">
                    <a16:creationId xmlns:a16="http://schemas.microsoft.com/office/drawing/2014/main" id="{A2526E59-53A1-C9C5-94DB-80F7C6963F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35741" y="5638114"/>
                <a:ext cx="73152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5B374188-329E-9048-820D-7DF520A5F19E}"/>
                </a:ext>
              </a:extLst>
            </p:cNvPr>
            <p:cNvSpPr txBox="1"/>
            <p:nvPr/>
          </p:nvSpPr>
          <p:spPr>
            <a:xfrm>
              <a:off x="1770593" y="5681982"/>
              <a:ext cx="16562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WT           </a:t>
              </a:r>
              <a:r>
                <a:rPr lang="en-US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Asc</a:t>
              </a:r>
              <a:r>
                <a:rPr lang="en-US" sz="14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 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387D99E1-5AD0-4249-9267-6E06D54A48D8}"/>
                </a:ext>
              </a:extLst>
            </p:cNvPr>
            <p:cNvSpPr txBox="1"/>
            <p:nvPr/>
          </p:nvSpPr>
          <p:spPr>
            <a:xfrm flipH="1">
              <a:off x="955299" y="4609333"/>
              <a:ext cx="6669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p-p65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FFD49C7F-2173-4740-B3F3-C371600761E4}"/>
                </a:ext>
              </a:extLst>
            </p:cNvPr>
            <p:cNvSpPr txBox="1"/>
            <p:nvPr/>
          </p:nvSpPr>
          <p:spPr>
            <a:xfrm flipH="1">
              <a:off x="1107694" y="4976887"/>
              <a:ext cx="6669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p65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9323D5D1-DF2B-B74E-8273-7D2D5B10BFFB}"/>
                </a:ext>
              </a:extLst>
            </p:cNvPr>
            <p:cNvSpPr txBox="1"/>
            <p:nvPr/>
          </p:nvSpPr>
          <p:spPr>
            <a:xfrm flipH="1">
              <a:off x="1023421" y="5269136"/>
              <a:ext cx="6669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</p:grpSp>
      <p:sp>
        <p:nvSpPr>
          <p:cNvPr id="60" name="TextBox 59">
            <a:extLst>
              <a:ext uri="{FF2B5EF4-FFF2-40B4-BE49-F238E27FC236}">
                <a16:creationId xmlns:a16="http://schemas.microsoft.com/office/drawing/2014/main" id="{17B69137-3E8D-544C-83D0-2F15D3F27B9D}"/>
              </a:ext>
            </a:extLst>
          </p:cNvPr>
          <p:cNvSpPr txBox="1"/>
          <p:nvPr/>
        </p:nvSpPr>
        <p:spPr>
          <a:xfrm>
            <a:off x="1130290" y="1310471"/>
            <a:ext cx="87324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                                                       B                                                   C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DCCC59E-AB78-3941-B63D-0CEB9BCA7DC0}"/>
              </a:ext>
            </a:extLst>
          </p:cNvPr>
          <p:cNvSpPr txBox="1"/>
          <p:nvPr/>
        </p:nvSpPr>
        <p:spPr>
          <a:xfrm>
            <a:off x="163794" y="5959736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</p:spTree>
    <p:extLst>
      <p:ext uri="{BB962C8B-B14F-4D97-AF65-F5344CB8AC3E}">
        <p14:creationId xmlns:p14="http://schemas.microsoft.com/office/powerpoint/2010/main" val="21586128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C1FF8EA-CF98-75FB-524E-C9F2A4956AB8}"/>
              </a:ext>
            </a:extLst>
          </p:cNvPr>
          <p:cNvSpPr txBox="1"/>
          <p:nvPr/>
        </p:nvSpPr>
        <p:spPr>
          <a:xfrm>
            <a:off x="388010" y="1063044"/>
            <a:ext cx="87324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                                                             B                                                                       C 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185661A2-0C49-B14D-90B5-26C5E4860D08}"/>
              </a:ext>
            </a:extLst>
          </p:cNvPr>
          <p:cNvGrpSpPr/>
          <p:nvPr/>
        </p:nvGrpSpPr>
        <p:grpSpPr>
          <a:xfrm>
            <a:off x="8408673" y="1113468"/>
            <a:ext cx="3735877" cy="2202516"/>
            <a:chOff x="6290075" y="1076426"/>
            <a:chExt cx="3735877" cy="2202516"/>
          </a:xfrm>
        </p:grpSpPr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36B18093-B722-5A37-8E46-5608E386D93F}"/>
                </a:ext>
              </a:extLst>
            </p:cNvPr>
            <p:cNvGrpSpPr/>
            <p:nvPr/>
          </p:nvGrpSpPr>
          <p:grpSpPr>
            <a:xfrm>
              <a:off x="6928825" y="1076426"/>
              <a:ext cx="2592730" cy="1837148"/>
              <a:chOff x="6928825" y="1076426"/>
              <a:chExt cx="2592730" cy="1837148"/>
            </a:xfrm>
          </p:grpSpPr>
          <p:grpSp>
            <p:nvGrpSpPr>
              <p:cNvPr id="81" name="Group 80">
                <a:extLst>
                  <a:ext uri="{FF2B5EF4-FFF2-40B4-BE49-F238E27FC236}">
                    <a16:creationId xmlns:a16="http://schemas.microsoft.com/office/drawing/2014/main" id="{D39D37D3-0003-39AD-4CD1-A6EF63B8187B}"/>
                  </a:ext>
                </a:extLst>
              </p:cNvPr>
              <p:cNvGrpSpPr/>
              <p:nvPr/>
            </p:nvGrpSpPr>
            <p:grpSpPr>
              <a:xfrm>
                <a:off x="6928825" y="1076426"/>
                <a:ext cx="2592730" cy="1746247"/>
                <a:chOff x="4926360" y="1400243"/>
                <a:chExt cx="2592730" cy="1746247"/>
              </a:xfrm>
            </p:grpSpPr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07DF0207-B3F8-62C5-3AAF-7312FBB87A15}"/>
                    </a:ext>
                  </a:extLst>
                </p:cNvPr>
                <p:cNvSpPr txBox="1"/>
                <p:nvPr/>
              </p:nvSpPr>
              <p:spPr>
                <a:xfrm>
                  <a:off x="4926360" y="1400243"/>
                  <a:ext cx="259273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8hr Spleen</a:t>
                  </a:r>
                </a:p>
              </p:txBody>
            </p:sp>
            <p:grpSp>
              <p:nvGrpSpPr>
                <p:cNvPr id="36" name="Group 35">
                  <a:extLst>
                    <a:ext uri="{FF2B5EF4-FFF2-40B4-BE49-F238E27FC236}">
                      <a16:creationId xmlns:a16="http://schemas.microsoft.com/office/drawing/2014/main" id="{20E26E48-4652-74B3-951F-ADFF81919314}"/>
                    </a:ext>
                  </a:extLst>
                </p:cNvPr>
                <p:cNvGrpSpPr/>
                <p:nvPr/>
              </p:nvGrpSpPr>
              <p:grpSpPr>
                <a:xfrm>
                  <a:off x="4959364" y="1814350"/>
                  <a:ext cx="2550885" cy="1332140"/>
                  <a:chOff x="1888184" y="1869099"/>
                  <a:chExt cx="2641753" cy="1323862"/>
                </a:xfrm>
              </p:grpSpPr>
              <p:pic>
                <p:nvPicPr>
                  <p:cNvPr id="12" name="Picture 11" descr="A group of black spots on a white surface&#10;&#10;Description automatically generated">
                    <a:extLst>
                      <a:ext uri="{FF2B5EF4-FFF2-40B4-BE49-F238E27FC236}">
                        <a16:creationId xmlns:a16="http://schemas.microsoft.com/office/drawing/2014/main" id="{92DF4C0D-560A-6F11-9AFA-EE0D4D51F97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/>
                  <a:stretch>
                    <a:fillRect/>
                  </a:stretch>
                </p:blipFill>
                <p:spPr>
                  <a:xfrm flipH="1">
                    <a:off x="1888184" y="2270680"/>
                    <a:ext cx="2641600" cy="520700"/>
                  </a:xfrm>
                  <a:prstGeom prst="rect">
                    <a:avLst/>
                  </a:prstGeom>
                </p:spPr>
              </p:pic>
              <p:pic>
                <p:nvPicPr>
                  <p:cNvPr id="13" name="Picture 12" descr="A black dot on a white surface&#10;&#10;Description automatically generated">
                    <a:extLst>
                      <a:ext uri="{FF2B5EF4-FFF2-40B4-BE49-F238E27FC236}">
                        <a16:creationId xmlns:a16="http://schemas.microsoft.com/office/drawing/2014/main" id="{1C81CF06-C0DC-BE98-7D91-11D880F1E09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 flipH="1">
                    <a:off x="1888184" y="1869099"/>
                    <a:ext cx="2641600" cy="368300"/>
                  </a:xfrm>
                  <a:prstGeom prst="rect">
                    <a:avLst/>
                  </a:prstGeom>
                </p:spPr>
              </p:pic>
              <p:pic>
                <p:nvPicPr>
                  <p:cNvPr id="34" name="Picture 33" descr="A blurry image of a couple of black objects&#10;&#10;Description automatically generated">
                    <a:extLst>
                      <a:ext uri="{FF2B5EF4-FFF2-40B4-BE49-F238E27FC236}">
                        <a16:creationId xmlns:a16="http://schemas.microsoft.com/office/drawing/2014/main" id="{CE9A15BF-C4D4-D4ED-025E-D2E6C49D04D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 flipH="1">
                    <a:off x="1888337" y="2824661"/>
                    <a:ext cx="2641600" cy="368300"/>
                  </a:xfrm>
                  <a:prstGeom prst="rect">
                    <a:avLst/>
                  </a:prstGeom>
                </p:spPr>
              </p:pic>
            </p:grpSp>
          </p:grpSp>
          <p:cxnSp>
            <p:nvCxnSpPr>
              <p:cNvPr id="63" name="Straight Connector 62">
                <a:extLst>
                  <a:ext uri="{FF2B5EF4-FFF2-40B4-BE49-F238E27FC236}">
                    <a16:creationId xmlns:a16="http://schemas.microsoft.com/office/drawing/2014/main" id="{0381F4F9-3949-99B8-28C8-EF938F177F6D}"/>
                  </a:ext>
                </a:extLst>
              </p:cNvPr>
              <p:cNvCxnSpPr/>
              <p:nvPr/>
            </p:nvCxnSpPr>
            <p:spPr>
              <a:xfrm>
                <a:off x="7002029" y="2913574"/>
                <a:ext cx="862387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Straight Connector 63">
                <a:extLst>
                  <a:ext uri="{FF2B5EF4-FFF2-40B4-BE49-F238E27FC236}">
                    <a16:creationId xmlns:a16="http://schemas.microsoft.com/office/drawing/2014/main" id="{D8C4DBF8-E7A9-2EC4-0F7F-3A19C61B587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51073" y="2913574"/>
                <a:ext cx="572251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" name="Straight Connector 65">
                <a:extLst>
                  <a:ext uri="{FF2B5EF4-FFF2-40B4-BE49-F238E27FC236}">
                    <a16:creationId xmlns:a16="http://schemas.microsoft.com/office/drawing/2014/main" id="{F1D5065C-16DC-394C-4F7F-74E70EB619CB}"/>
                  </a:ext>
                </a:extLst>
              </p:cNvPr>
              <p:cNvCxnSpPr/>
              <p:nvPr/>
            </p:nvCxnSpPr>
            <p:spPr>
              <a:xfrm>
                <a:off x="8626894" y="2913574"/>
                <a:ext cx="862387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C517C47A-10E9-C343-A9CA-4E0A97A7A45C}"/>
                </a:ext>
              </a:extLst>
            </p:cNvPr>
            <p:cNvSpPr txBox="1"/>
            <p:nvPr/>
          </p:nvSpPr>
          <p:spPr>
            <a:xfrm>
              <a:off x="7214339" y="2971165"/>
              <a:ext cx="28116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WT         </a:t>
              </a:r>
              <a:r>
                <a:rPr lang="en-US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Aim2</a:t>
              </a:r>
              <a:r>
                <a:rPr lang="en-US" sz="14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 </a:t>
              </a:r>
              <a:r>
                <a:rPr lang="en-US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      </a:t>
              </a:r>
              <a:r>
                <a:rPr lang="en-US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Nlrp3</a:t>
              </a:r>
              <a:r>
                <a:rPr lang="en-US" sz="14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 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AE9E6685-8E0A-0744-9BD6-073BBFD40F6D}"/>
                </a:ext>
              </a:extLst>
            </p:cNvPr>
            <p:cNvSpPr txBox="1"/>
            <p:nvPr/>
          </p:nvSpPr>
          <p:spPr>
            <a:xfrm flipH="1">
              <a:off x="6290075" y="1516025"/>
              <a:ext cx="6669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p-p65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555E0AE0-A706-844F-8194-F89511A59515}"/>
                </a:ext>
              </a:extLst>
            </p:cNvPr>
            <p:cNvSpPr txBox="1"/>
            <p:nvPr/>
          </p:nvSpPr>
          <p:spPr>
            <a:xfrm flipH="1">
              <a:off x="6442470" y="1991159"/>
              <a:ext cx="6669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p65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D6528DA2-28F3-A74B-85DE-E4DCD1884468}"/>
                </a:ext>
              </a:extLst>
            </p:cNvPr>
            <p:cNvSpPr txBox="1"/>
            <p:nvPr/>
          </p:nvSpPr>
          <p:spPr>
            <a:xfrm flipH="1">
              <a:off x="6358197" y="2477047"/>
              <a:ext cx="6669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AAF73FAA-5829-4947-96F7-7AED0F7F13DF}"/>
              </a:ext>
            </a:extLst>
          </p:cNvPr>
          <p:cNvGrpSpPr/>
          <p:nvPr/>
        </p:nvGrpSpPr>
        <p:grpSpPr>
          <a:xfrm>
            <a:off x="162114" y="1227036"/>
            <a:ext cx="3946352" cy="1901795"/>
            <a:chOff x="349854" y="1152536"/>
            <a:chExt cx="3946352" cy="1901795"/>
          </a:xfrm>
        </p:grpSpPr>
        <p:grpSp>
          <p:nvGrpSpPr>
            <p:cNvPr id="62" name="Group 61">
              <a:extLst>
                <a:ext uri="{FF2B5EF4-FFF2-40B4-BE49-F238E27FC236}">
                  <a16:creationId xmlns:a16="http://schemas.microsoft.com/office/drawing/2014/main" id="{0C6838BD-3AD0-A017-E666-43804A928560}"/>
                </a:ext>
              </a:extLst>
            </p:cNvPr>
            <p:cNvGrpSpPr/>
            <p:nvPr/>
          </p:nvGrpSpPr>
          <p:grpSpPr>
            <a:xfrm>
              <a:off x="1016147" y="1152536"/>
              <a:ext cx="3280059" cy="1901795"/>
              <a:chOff x="1016147" y="1152536"/>
              <a:chExt cx="3280059" cy="1901795"/>
            </a:xfrm>
          </p:grpSpPr>
          <p:grpSp>
            <p:nvGrpSpPr>
              <p:cNvPr id="106" name="Group 105">
                <a:extLst>
                  <a:ext uri="{FF2B5EF4-FFF2-40B4-BE49-F238E27FC236}">
                    <a16:creationId xmlns:a16="http://schemas.microsoft.com/office/drawing/2014/main" id="{346035CB-F47A-D35B-89A4-EF57038F69B2}"/>
                  </a:ext>
                </a:extLst>
              </p:cNvPr>
              <p:cNvGrpSpPr/>
              <p:nvPr/>
            </p:nvGrpSpPr>
            <p:grpSpPr>
              <a:xfrm>
                <a:off x="1016147" y="1152536"/>
                <a:ext cx="3058388" cy="1424438"/>
                <a:chOff x="935124" y="1478585"/>
                <a:chExt cx="3058388" cy="1424438"/>
              </a:xfrm>
            </p:grpSpPr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B2CDCCD2-FD94-7D0D-18DE-0468B891664E}"/>
                    </a:ext>
                  </a:extLst>
                </p:cNvPr>
                <p:cNvSpPr txBox="1"/>
                <p:nvPr/>
              </p:nvSpPr>
              <p:spPr>
                <a:xfrm>
                  <a:off x="1051133" y="1478585"/>
                  <a:ext cx="273285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4hr Spleen </a:t>
                  </a:r>
                </a:p>
              </p:txBody>
            </p:sp>
            <p:grpSp>
              <p:nvGrpSpPr>
                <p:cNvPr id="84" name="Group 83">
                  <a:extLst>
                    <a:ext uri="{FF2B5EF4-FFF2-40B4-BE49-F238E27FC236}">
                      <a16:creationId xmlns:a16="http://schemas.microsoft.com/office/drawing/2014/main" id="{47A91872-3338-6EF9-504C-C1EBE696652B}"/>
                    </a:ext>
                  </a:extLst>
                </p:cNvPr>
                <p:cNvGrpSpPr/>
                <p:nvPr/>
              </p:nvGrpSpPr>
              <p:grpSpPr>
                <a:xfrm>
                  <a:off x="935124" y="1861635"/>
                  <a:ext cx="3058388" cy="1041388"/>
                  <a:chOff x="1861079" y="3680290"/>
                  <a:chExt cx="3058388" cy="1041388"/>
                </a:xfrm>
              </p:grpSpPr>
              <p:pic>
                <p:nvPicPr>
                  <p:cNvPr id="85" name="Picture 84">
                    <a:extLst>
                      <a:ext uri="{FF2B5EF4-FFF2-40B4-BE49-F238E27FC236}">
                        <a16:creationId xmlns:a16="http://schemas.microsoft.com/office/drawing/2014/main" id="{BFC03EAE-91C9-AF8E-CE71-63F41AD58AE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1886857" y="4454978"/>
                    <a:ext cx="2997200" cy="266700"/>
                  </a:xfrm>
                  <a:prstGeom prst="rect">
                    <a:avLst/>
                  </a:prstGeom>
                </p:spPr>
              </p:pic>
              <p:pic>
                <p:nvPicPr>
                  <p:cNvPr id="87" name="Picture 86" descr="A black and white photo&#10;&#10;Description automatically generated">
                    <a:extLst>
                      <a:ext uri="{FF2B5EF4-FFF2-40B4-BE49-F238E27FC236}">
                        <a16:creationId xmlns:a16="http://schemas.microsoft.com/office/drawing/2014/main" id="{9E131A9A-68C7-10EC-7DB1-A9AAC6FA59C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1884167" y="4001845"/>
                    <a:ext cx="3035300" cy="393700"/>
                  </a:xfrm>
                  <a:prstGeom prst="rect">
                    <a:avLst/>
                  </a:prstGeom>
                </p:spPr>
              </p:pic>
              <p:pic>
                <p:nvPicPr>
                  <p:cNvPr id="89" name="Picture 88">
                    <a:extLst>
                      <a:ext uri="{FF2B5EF4-FFF2-40B4-BE49-F238E27FC236}">
                        <a16:creationId xmlns:a16="http://schemas.microsoft.com/office/drawing/2014/main" id="{150E3FF4-A770-D44B-3831-2C03ED7A57C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/>
                  <a:stretch>
                    <a:fillRect/>
                  </a:stretch>
                </p:blipFill>
                <p:spPr>
                  <a:xfrm>
                    <a:off x="1861079" y="3680290"/>
                    <a:ext cx="3035300" cy="266700"/>
                  </a:xfrm>
                  <a:prstGeom prst="rect">
                    <a:avLst/>
                  </a:prstGeom>
                </p:spPr>
              </p:pic>
            </p:grpSp>
          </p:grp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271122E6-1E9F-719F-839E-6A3E618F82A5}"/>
                  </a:ext>
                </a:extLst>
              </p:cNvPr>
              <p:cNvSpPr txBox="1"/>
              <p:nvPr/>
            </p:nvSpPr>
            <p:spPr>
              <a:xfrm>
                <a:off x="1252818" y="2746554"/>
                <a:ext cx="304338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             </a:t>
                </a:r>
                <a:r>
                  <a:rPr lang="en-US" sz="14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Aim2</a:t>
                </a:r>
                <a:r>
                  <a:rPr lang="en-US" sz="140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/- </a:t>
                </a:r>
                <a:r>
                  <a:rPr lang="en-US" sz="14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</a:t>
                </a:r>
                <a:r>
                  <a:rPr lang="en-US" sz="14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lrp3</a:t>
                </a:r>
                <a:r>
                  <a:rPr lang="en-US" sz="140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/- 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" name="Straight Connector 16">
                <a:extLst>
                  <a:ext uri="{FF2B5EF4-FFF2-40B4-BE49-F238E27FC236}">
                    <a16:creationId xmlns:a16="http://schemas.microsoft.com/office/drawing/2014/main" id="{F42A4C11-1FC5-12A9-FD67-F17663DCFBE0}"/>
                  </a:ext>
                </a:extLst>
              </p:cNvPr>
              <p:cNvCxnSpPr/>
              <p:nvPr/>
            </p:nvCxnSpPr>
            <p:spPr>
              <a:xfrm>
                <a:off x="1092657" y="2690406"/>
                <a:ext cx="862387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152CE8BF-4D01-2AEC-5128-BAB1AFE73815}"/>
                  </a:ext>
                </a:extLst>
              </p:cNvPr>
              <p:cNvCxnSpPr/>
              <p:nvPr/>
            </p:nvCxnSpPr>
            <p:spPr>
              <a:xfrm>
                <a:off x="2074062" y="2690406"/>
                <a:ext cx="862387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F45A906E-E7E6-AAA9-A641-1F7150308DE1}"/>
                  </a:ext>
                </a:extLst>
              </p:cNvPr>
              <p:cNvCxnSpPr/>
              <p:nvPr/>
            </p:nvCxnSpPr>
            <p:spPr>
              <a:xfrm>
                <a:off x="3088426" y="2690406"/>
                <a:ext cx="862387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F94D3487-AE41-9046-A5CF-8662ABBA4204}"/>
                </a:ext>
              </a:extLst>
            </p:cNvPr>
            <p:cNvSpPr txBox="1"/>
            <p:nvPr/>
          </p:nvSpPr>
          <p:spPr>
            <a:xfrm flipH="1">
              <a:off x="349854" y="1507722"/>
              <a:ext cx="6669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p-p65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98BB8D01-DAB3-9746-9CD3-CC79C9465D75}"/>
                </a:ext>
              </a:extLst>
            </p:cNvPr>
            <p:cNvSpPr txBox="1"/>
            <p:nvPr/>
          </p:nvSpPr>
          <p:spPr>
            <a:xfrm flipH="1">
              <a:off x="502249" y="1907550"/>
              <a:ext cx="6669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p65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09DDDFDE-2A99-C346-8F43-423FC57FE6D5}"/>
                </a:ext>
              </a:extLst>
            </p:cNvPr>
            <p:cNvSpPr txBox="1"/>
            <p:nvPr/>
          </p:nvSpPr>
          <p:spPr>
            <a:xfrm flipH="1">
              <a:off x="417976" y="2275105"/>
              <a:ext cx="6669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BFAFF4AC-712E-B64E-99B4-00E528D4E01C}"/>
              </a:ext>
            </a:extLst>
          </p:cNvPr>
          <p:cNvGrpSpPr/>
          <p:nvPr/>
        </p:nvGrpSpPr>
        <p:grpSpPr>
          <a:xfrm>
            <a:off x="4115538" y="1113468"/>
            <a:ext cx="4102439" cy="2160395"/>
            <a:chOff x="336286" y="3948066"/>
            <a:chExt cx="4102439" cy="2160395"/>
          </a:xfrm>
        </p:grpSpPr>
        <p:grpSp>
          <p:nvGrpSpPr>
            <p:cNvPr id="73" name="Group 72">
              <a:extLst>
                <a:ext uri="{FF2B5EF4-FFF2-40B4-BE49-F238E27FC236}">
                  <a16:creationId xmlns:a16="http://schemas.microsoft.com/office/drawing/2014/main" id="{70BC8E20-EAE0-38E1-53A3-02369CA3322D}"/>
                </a:ext>
              </a:extLst>
            </p:cNvPr>
            <p:cNvGrpSpPr/>
            <p:nvPr/>
          </p:nvGrpSpPr>
          <p:grpSpPr>
            <a:xfrm>
              <a:off x="1016147" y="3948066"/>
              <a:ext cx="3175010" cy="1759860"/>
              <a:chOff x="1016147" y="3948066"/>
              <a:chExt cx="3175010" cy="1759860"/>
            </a:xfrm>
          </p:grpSpPr>
          <p:grpSp>
            <p:nvGrpSpPr>
              <p:cNvPr id="82" name="Group 81">
                <a:extLst>
                  <a:ext uri="{FF2B5EF4-FFF2-40B4-BE49-F238E27FC236}">
                    <a16:creationId xmlns:a16="http://schemas.microsoft.com/office/drawing/2014/main" id="{34C2DFDB-CDB0-F2A0-6EE2-875DF0CD34E9}"/>
                  </a:ext>
                </a:extLst>
              </p:cNvPr>
              <p:cNvGrpSpPr/>
              <p:nvPr/>
            </p:nvGrpSpPr>
            <p:grpSpPr>
              <a:xfrm>
                <a:off x="1016147" y="3948066"/>
                <a:ext cx="3175010" cy="1637393"/>
                <a:chOff x="1247073" y="4071128"/>
                <a:chExt cx="3175010" cy="1637393"/>
              </a:xfrm>
            </p:grpSpPr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626DF516-1A3E-0474-AEE3-D3751ACDAFA2}"/>
                    </a:ext>
                  </a:extLst>
                </p:cNvPr>
                <p:cNvSpPr txBox="1"/>
                <p:nvPr/>
              </p:nvSpPr>
              <p:spPr>
                <a:xfrm>
                  <a:off x="1343249" y="4071128"/>
                  <a:ext cx="2911749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4hr Liver</a:t>
                  </a:r>
                </a:p>
              </p:txBody>
            </p:sp>
            <p:grpSp>
              <p:nvGrpSpPr>
                <p:cNvPr id="37" name="Group 36">
                  <a:extLst>
                    <a:ext uri="{FF2B5EF4-FFF2-40B4-BE49-F238E27FC236}">
                      <a16:creationId xmlns:a16="http://schemas.microsoft.com/office/drawing/2014/main" id="{280E9A40-A962-40AA-616B-E8493D7A6A9F}"/>
                    </a:ext>
                  </a:extLst>
                </p:cNvPr>
                <p:cNvGrpSpPr/>
                <p:nvPr/>
              </p:nvGrpSpPr>
              <p:grpSpPr>
                <a:xfrm>
                  <a:off x="1247073" y="4493938"/>
                  <a:ext cx="3175010" cy="1214583"/>
                  <a:chOff x="7816635" y="2941237"/>
                  <a:chExt cx="3175010" cy="1214583"/>
                </a:xfrm>
              </p:grpSpPr>
              <p:pic>
                <p:nvPicPr>
                  <p:cNvPr id="38" name="Picture 37">
                    <a:extLst>
                      <a:ext uri="{FF2B5EF4-FFF2-40B4-BE49-F238E27FC236}">
                        <a16:creationId xmlns:a16="http://schemas.microsoft.com/office/drawing/2014/main" id="{758974F7-D5DC-D345-81E2-31698783D9D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8"/>
                  <a:stretch>
                    <a:fillRect/>
                  </a:stretch>
                </p:blipFill>
                <p:spPr>
                  <a:xfrm flipH="1">
                    <a:off x="7816635" y="2941237"/>
                    <a:ext cx="3111500" cy="381000"/>
                  </a:xfrm>
                  <a:prstGeom prst="rect">
                    <a:avLst/>
                  </a:prstGeom>
                </p:spPr>
              </p:pic>
              <p:pic>
                <p:nvPicPr>
                  <p:cNvPr id="56" name="Picture 55" descr="A black line on a white surface&#10;&#10;Description automatically generated">
                    <a:extLst>
                      <a:ext uri="{FF2B5EF4-FFF2-40B4-BE49-F238E27FC236}">
                        <a16:creationId xmlns:a16="http://schemas.microsoft.com/office/drawing/2014/main" id="{CED9F5FB-EEAD-37A7-9E08-60B5335067A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9"/>
                  <a:stretch>
                    <a:fillRect/>
                  </a:stretch>
                </p:blipFill>
                <p:spPr>
                  <a:xfrm flipH="1">
                    <a:off x="7816645" y="3749420"/>
                    <a:ext cx="3175000" cy="406400"/>
                  </a:xfrm>
                  <a:prstGeom prst="rect">
                    <a:avLst/>
                  </a:prstGeom>
                </p:spPr>
              </p:pic>
              <p:pic>
                <p:nvPicPr>
                  <p:cNvPr id="58" name="Picture 57">
                    <a:extLst>
                      <a:ext uri="{FF2B5EF4-FFF2-40B4-BE49-F238E27FC236}">
                        <a16:creationId xmlns:a16="http://schemas.microsoft.com/office/drawing/2014/main" id="{A0DF819A-4B45-95AC-C01A-E3BD4F5D047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0"/>
                  <a:srcRect t="1" r="4791" b="3039"/>
                  <a:stretch/>
                </p:blipFill>
                <p:spPr>
                  <a:xfrm flipH="1">
                    <a:off x="7816635" y="3411832"/>
                    <a:ext cx="3143816" cy="283222"/>
                  </a:xfrm>
                  <a:prstGeom prst="rect">
                    <a:avLst/>
                  </a:prstGeom>
                </p:spPr>
              </p:pic>
            </p:grpSp>
          </p:grp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33D99567-2AAD-4F45-AC37-659C6979917D}"/>
                  </a:ext>
                </a:extLst>
              </p:cNvPr>
              <p:cNvCxnSpPr/>
              <p:nvPr/>
            </p:nvCxnSpPr>
            <p:spPr>
              <a:xfrm>
                <a:off x="1079366" y="5707926"/>
                <a:ext cx="862387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Straight Connector 70">
                <a:extLst>
                  <a:ext uri="{FF2B5EF4-FFF2-40B4-BE49-F238E27FC236}">
                    <a16:creationId xmlns:a16="http://schemas.microsoft.com/office/drawing/2014/main" id="{F711AEB1-9826-9966-D620-2E56393854A3}"/>
                  </a:ext>
                </a:extLst>
              </p:cNvPr>
              <p:cNvCxnSpPr/>
              <p:nvPr/>
            </p:nvCxnSpPr>
            <p:spPr>
              <a:xfrm>
                <a:off x="3261696" y="5707926"/>
                <a:ext cx="862387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Straight Connector 71">
                <a:extLst>
                  <a:ext uri="{FF2B5EF4-FFF2-40B4-BE49-F238E27FC236}">
                    <a16:creationId xmlns:a16="http://schemas.microsoft.com/office/drawing/2014/main" id="{42E171B9-503B-8FFF-3F89-44604899BA08}"/>
                  </a:ext>
                </a:extLst>
              </p:cNvPr>
              <p:cNvCxnSpPr/>
              <p:nvPr/>
            </p:nvCxnSpPr>
            <p:spPr>
              <a:xfrm>
                <a:off x="2172463" y="5707926"/>
                <a:ext cx="862387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D771CB0F-B46F-D645-AC04-DBC34BE27E1F}"/>
                </a:ext>
              </a:extLst>
            </p:cNvPr>
            <p:cNvSpPr txBox="1"/>
            <p:nvPr/>
          </p:nvSpPr>
          <p:spPr>
            <a:xfrm>
              <a:off x="1266087" y="5800684"/>
              <a:ext cx="31726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WT              </a:t>
              </a:r>
              <a:r>
                <a:rPr lang="en-US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Aim2</a:t>
              </a:r>
              <a:r>
                <a:rPr lang="en-US" sz="14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 </a:t>
              </a:r>
              <a:r>
                <a:rPr lang="en-US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</a:t>
              </a:r>
              <a:r>
                <a:rPr lang="en-US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Nlrp3</a:t>
              </a:r>
              <a:r>
                <a:rPr lang="en-US" sz="14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 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49521186-7CCD-4C44-8899-97A10AA4C77E}"/>
                </a:ext>
              </a:extLst>
            </p:cNvPr>
            <p:cNvSpPr txBox="1"/>
            <p:nvPr/>
          </p:nvSpPr>
          <p:spPr>
            <a:xfrm flipH="1">
              <a:off x="336286" y="4407688"/>
              <a:ext cx="6669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p-p65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0725DBEB-793B-074D-A2FF-B4C2806067D0}"/>
                </a:ext>
              </a:extLst>
            </p:cNvPr>
            <p:cNvSpPr txBox="1"/>
            <p:nvPr/>
          </p:nvSpPr>
          <p:spPr>
            <a:xfrm flipH="1">
              <a:off x="488681" y="4829032"/>
              <a:ext cx="6669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p65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8644C020-FAF5-6546-89E0-F598362CFB3F}"/>
                </a:ext>
              </a:extLst>
            </p:cNvPr>
            <p:cNvSpPr txBox="1"/>
            <p:nvPr/>
          </p:nvSpPr>
          <p:spPr>
            <a:xfrm flipH="1">
              <a:off x="404408" y="5218103"/>
              <a:ext cx="6669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</p:grpSp>
      <p:sp>
        <p:nvSpPr>
          <p:cNvPr id="48" name="TextBox 47">
            <a:extLst>
              <a:ext uri="{FF2B5EF4-FFF2-40B4-BE49-F238E27FC236}">
                <a16:creationId xmlns:a16="http://schemas.microsoft.com/office/drawing/2014/main" id="{948A0656-DE22-6043-8F35-ADAEBAD1B1B6}"/>
              </a:ext>
            </a:extLst>
          </p:cNvPr>
          <p:cNvSpPr txBox="1"/>
          <p:nvPr/>
        </p:nvSpPr>
        <p:spPr>
          <a:xfrm>
            <a:off x="163794" y="5959736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</p:spTree>
    <p:extLst>
      <p:ext uri="{BB962C8B-B14F-4D97-AF65-F5344CB8AC3E}">
        <p14:creationId xmlns:p14="http://schemas.microsoft.com/office/powerpoint/2010/main" val="31849279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</TotalTime>
  <Words>66</Words>
  <Application>Microsoft Macintosh PowerPoint</Application>
  <PresentationFormat>Widescreen</PresentationFormat>
  <Paragraphs>3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ias, Anika M - (anikatriplet1)</dc:creator>
  <cp:lastModifiedBy>Wilson, Justin - (wilsonje)</cp:lastModifiedBy>
  <cp:revision>20</cp:revision>
  <dcterms:created xsi:type="dcterms:W3CDTF">2025-03-10T17:59:50Z</dcterms:created>
  <dcterms:modified xsi:type="dcterms:W3CDTF">2025-03-11T21:57:02Z</dcterms:modified>
</cp:coreProperties>
</file>